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287" r:id="rId2"/>
  </p:sldIdLst>
  <p:sldSz cx="6858000" cy="9144000" type="screen4x3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D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6306" autoAdjust="0"/>
  </p:normalViewPr>
  <p:slideViewPr>
    <p:cSldViewPr snapToGrid="0">
      <p:cViewPr varScale="1">
        <p:scale>
          <a:sx n="76" d="100"/>
          <a:sy n="76" d="100"/>
        </p:scale>
        <p:origin x="3210" y="9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82" d="100"/>
        <a:sy n="8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/>
              <a:t>Anti-Flea</a:t>
            </a:r>
            <a:r>
              <a:rPr lang="en-US" sz="1400" baseline="0"/>
              <a:t> </a:t>
            </a:r>
            <a:endParaRPr lang="en-US" sz="14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401978598828993"/>
          <c:y val="0.17372352525510318"/>
          <c:w val="0.79072380375529983"/>
          <c:h val="0.697533902012248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 Flea'!$E$69</c:f>
              <c:strCache>
                <c:ptCount val="1"/>
                <c:pt idx="0">
                  <c:v>IgG1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Flea'!$F$74:$H$74</c:f>
                <c:numCache>
                  <c:formatCode>General</c:formatCode>
                  <c:ptCount val="3"/>
                  <c:pt idx="0">
                    <c:v>16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Sheet Flea'!$F$74:$H$74</c:f>
                <c:numCache>
                  <c:formatCode>General</c:formatCode>
                  <c:ptCount val="3"/>
                  <c:pt idx="0">
                    <c:v>16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Flea'!$F$68:$H$68</c:f>
              <c:strCache>
                <c:ptCount val="3"/>
                <c:pt idx="0">
                  <c:v>CryJ1</c:v>
                </c:pt>
                <c:pt idx="1">
                  <c:v>CryJ2</c:v>
                </c:pt>
                <c:pt idx="2">
                  <c:v>Control</c:v>
                </c:pt>
              </c:strCache>
            </c:strRef>
          </c:cat>
          <c:val>
            <c:numRef>
              <c:f>'Sheet Flea'!$F$69:$H$69</c:f>
              <c:numCache>
                <c:formatCode>General</c:formatCode>
                <c:ptCount val="3"/>
                <c:pt idx="0">
                  <c:v>26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Sheet Flea'!$E$70</c:f>
              <c:strCache>
                <c:ptCount val="1"/>
                <c:pt idx="0">
                  <c:v>IgG2a</c:v>
                </c:pt>
              </c:strCache>
            </c:strRef>
          </c:tx>
          <c:spPr>
            <a:solidFill>
              <a:srgbClr val="4FD1FF"/>
            </a:solidFill>
            <a:ln>
              <a:solidFill>
                <a:sysClr val="windowText" lastClr="000000">
                  <a:lumMod val="65000"/>
                  <a:lumOff val="35000"/>
                </a:sys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Flea'!$F$75:$H$75</c:f>
                <c:numCache>
                  <c:formatCode>General</c:formatCode>
                  <c:ptCount val="3"/>
                  <c:pt idx="0">
                    <c:v>48.989794855663561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Sheet Flea'!$F$75:$H$75</c:f>
                <c:numCache>
                  <c:formatCode>General</c:formatCode>
                  <c:ptCount val="3"/>
                  <c:pt idx="0">
                    <c:v>48.989794855663561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Flea'!$F$68:$H$68</c:f>
              <c:strCache>
                <c:ptCount val="3"/>
                <c:pt idx="0">
                  <c:v>CryJ1</c:v>
                </c:pt>
                <c:pt idx="1">
                  <c:v>CryJ2</c:v>
                </c:pt>
                <c:pt idx="2">
                  <c:v>Control</c:v>
                </c:pt>
              </c:strCache>
            </c:strRef>
          </c:cat>
          <c:val>
            <c:numRef>
              <c:f>'Sheet Flea'!$F$70:$H$70</c:f>
              <c:numCache>
                <c:formatCode>General</c:formatCode>
                <c:ptCount val="3"/>
                <c:pt idx="0">
                  <c:v>18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28432"/>
        <c:axId val="147206304"/>
      </c:barChart>
      <c:catAx>
        <c:axId val="6028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206304"/>
        <c:crosses val="autoZero"/>
        <c:auto val="1"/>
        <c:lblAlgn val="ctr"/>
        <c:lblOffset val="100"/>
        <c:noMultiLvlLbl val="0"/>
      </c:catAx>
      <c:valAx>
        <c:axId val="147206304"/>
        <c:scaling>
          <c:orientation val="minMax"/>
          <c:max val="15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28432"/>
        <c:crosses val="autoZero"/>
        <c:crossBetween val="between"/>
        <c:majorUnit val="3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 smtClean="0"/>
              <a:t>Anti-Cry</a:t>
            </a:r>
            <a:r>
              <a:rPr lang="en-US" sz="1400" baseline="0" dirty="0" smtClean="0"/>
              <a:t>J2 </a:t>
            </a:r>
            <a:endParaRPr lang="en-US" sz="14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864938757655296"/>
          <c:y val="0.17372352525510318"/>
          <c:w val="0.78609434237386988"/>
          <c:h val="0.704478346456692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 J2'!$E$69</c:f>
              <c:strCache>
                <c:ptCount val="1"/>
                <c:pt idx="0">
                  <c:v>IgG1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J2'!$F$74:$H$74</c:f>
                <c:numCache>
                  <c:formatCode>General</c:formatCode>
                  <c:ptCount val="3"/>
                  <c:pt idx="0">
                    <c:v>146.96938456699067</c:v>
                  </c:pt>
                  <c:pt idx="1">
                    <c:v>570.6137047074842</c:v>
                  </c:pt>
                  <c:pt idx="2">
                    <c:v>48.989794855663561</c:v>
                  </c:pt>
                </c:numCache>
              </c:numRef>
            </c:plus>
            <c:minus>
              <c:numRef>
                <c:f>'Sheet J2'!$F$74:$H$74</c:f>
                <c:numCache>
                  <c:formatCode>General</c:formatCode>
                  <c:ptCount val="3"/>
                  <c:pt idx="0">
                    <c:v>146.96938456699067</c:v>
                  </c:pt>
                  <c:pt idx="1">
                    <c:v>570.6137047074842</c:v>
                  </c:pt>
                  <c:pt idx="2">
                    <c:v>48.98979485566356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J2'!$F$68:$H$68</c:f>
              <c:strCache>
                <c:ptCount val="3"/>
                <c:pt idx="0">
                  <c:v>CryJ1</c:v>
                </c:pt>
                <c:pt idx="1">
                  <c:v>CryJ2</c:v>
                </c:pt>
                <c:pt idx="2">
                  <c:v>Control</c:v>
                </c:pt>
              </c:strCache>
            </c:strRef>
          </c:cat>
          <c:val>
            <c:numRef>
              <c:f>'Sheet J2'!$F$69:$H$69</c:f>
              <c:numCache>
                <c:formatCode>General</c:formatCode>
                <c:ptCount val="3"/>
                <c:pt idx="0">
                  <c:v>540</c:v>
                </c:pt>
                <c:pt idx="1">
                  <c:v>1340</c:v>
                </c:pt>
                <c:pt idx="2">
                  <c:v>220</c:v>
                </c:pt>
              </c:numCache>
            </c:numRef>
          </c:val>
        </c:ser>
        <c:ser>
          <c:idx val="1"/>
          <c:order val="1"/>
          <c:tx>
            <c:strRef>
              <c:f>'Sheet J2'!$E$70</c:f>
              <c:strCache>
                <c:ptCount val="1"/>
                <c:pt idx="0">
                  <c:v>IgG2a</c:v>
                </c:pt>
              </c:strCache>
            </c:strRef>
          </c:tx>
          <c:spPr>
            <a:solidFill>
              <a:srgbClr val="4FD1FF"/>
            </a:solidFill>
            <a:ln>
              <a:solidFill>
                <a:sysClr val="windowText" lastClr="000000">
                  <a:lumMod val="65000"/>
                  <a:lumOff val="35000"/>
                </a:sys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J2'!$F$75:$H$75</c:f>
                <c:numCache>
                  <c:formatCode>General</c:formatCode>
                  <c:ptCount val="3"/>
                  <c:pt idx="0">
                    <c:v>154.91933384829667</c:v>
                  </c:pt>
                  <c:pt idx="1">
                    <c:v>5452.5590322343141</c:v>
                  </c:pt>
                  <c:pt idx="2">
                    <c:v>0</c:v>
                  </c:pt>
                </c:numCache>
              </c:numRef>
            </c:plus>
            <c:minus>
              <c:numRef>
                <c:f>'Sheet J2'!$F$75:$H$75</c:f>
                <c:numCache>
                  <c:formatCode>General</c:formatCode>
                  <c:ptCount val="3"/>
                  <c:pt idx="0">
                    <c:v>154.91933384829667</c:v>
                  </c:pt>
                  <c:pt idx="1">
                    <c:v>5452.5590322343141</c:v>
                  </c:pt>
                  <c:pt idx="2">
                    <c:v>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J2'!$F$68:$H$68</c:f>
              <c:strCache>
                <c:ptCount val="3"/>
                <c:pt idx="0">
                  <c:v>CryJ1</c:v>
                </c:pt>
                <c:pt idx="1">
                  <c:v>CryJ2</c:v>
                </c:pt>
                <c:pt idx="2">
                  <c:v>Control</c:v>
                </c:pt>
              </c:strCache>
            </c:strRef>
          </c:cat>
          <c:val>
            <c:numRef>
              <c:f>'Sheet J2'!$F$70:$H$70</c:f>
              <c:numCache>
                <c:formatCode>General</c:formatCode>
                <c:ptCount val="3"/>
                <c:pt idx="0">
                  <c:v>300</c:v>
                </c:pt>
                <c:pt idx="1">
                  <c:v>11420</c:v>
                </c:pt>
                <c:pt idx="2">
                  <c:v>1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8107824"/>
        <c:axId val="148512248"/>
      </c:barChart>
      <c:catAx>
        <c:axId val="148107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512248"/>
        <c:crosses val="autoZero"/>
        <c:auto val="1"/>
        <c:lblAlgn val="ctr"/>
        <c:lblOffset val="100"/>
        <c:noMultiLvlLbl val="0"/>
      </c:catAx>
      <c:valAx>
        <c:axId val="1485122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107824"/>
        <c:crosses val="autoZero"/>
        <c:crossBetween val="between"/>
        <c:majorUnit val="3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 smtClean="0"/>
              <a:t>Anti-Cry</a:t>
            </a:r>
            <a:r>
              <a:rPr lang="en-US" sz="1400" baseline="0" dirty="0" smtClean="0"/>
              <a:t>J1 </a:t>
            </a:r>
            <a:endParaRPr lang="en-US" sz="14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401978598828993"/>
          <c:y val="0.17372352525510318"/>
          <c:w val="0.79072380375529983"/>
          <c:h val="0.704478346456692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 J1'!$D$69</c:f>
              <c:strCache>
                <c:ptCount val="1"/>
                <c:pt idx="0">
                  <c:v>IgG1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J1'!$E$74:$G$74</c:f>
                <c:numCache>
                  <c:formatCode>General</c:formatCode>
                  <c:ptCount val="3"/>
                  <c:pt idx="0">
                    <c:v>154.91933384829667</c:v>
                  </c:pt>
                  <c:pt idx="1">
                    <c:v>195.95917942265424</c:v>
                  </c:pt>
                  <c:pt idx="2">
                    <c:v>40</c:v>
                  </c:pt>
                </c:numCache>
              </c:numRef>
            </c:plus>
            <c:minus>
              <c:numRef>
                <c:f>'Sheet J1'!$E$74:$G$74</c:f>
                <c:numCache>
                  <c:formatCode>General</c:formatCode>
                  <c:ptCount val="3"/>
                  <c:pt idx="0">
                    <c:v>154.91933384829667</c:v>
                  </c:pt>
                  <c:pt idx="1">
                    <c:v>195.95917942265424</c:v>
                  </c:pt>
                  <c:pt idx="2">
                    <c:v>4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J1'!$E$68:$G$68</c:f>
              <c:strCache>
                <c:ptCount val="3"/>
                <c:pt idx="0">
                  <c:v>CryJ1</c:v>
                </c:pt>
                <c:pt idx="1">
                  <c:v>Cry J2</c:v>
                </c:pt>
                <c:pt idx="2">
                  <c:v>Control</c:v>
                </c:pt>
              </c:strCache>
            </c:strRef>
          </c:cat>
          <c:val>
            <c:numRef>
              <c:f>'Sheet J1'!$E$69:$G$69</c:f>
              <c:numCache>
                <c:formatCode>General</c:formatCode>
                <c:ptCount val="3"/>
                <c:pt idx="0">
                  <c:v>300</c:v>
                </c:pt>
                <c:pt idx="1">
                  <c:v>580</c:v>
                </c:pt>
                <c:pt idx="2">
                  <c:v>140</c:v>
                </c:pt>
              </c:numCache>
            </c:numRef>
          </c:val>
        </c:ser>
        <c:ser>
          <c:idx val="1"/>
          <c:order val="1"/>
          <c:tx>
            <c:strRef>
              <c:f>'Sheet J1'!$D$70</c:f>
              <c:strCache>
                <c:ptCount val="1"/>
                <c:pt idx="0">
                  <c:v>IgG2a</c:v>
                </c:pt>
              </c:strCache>
            </c:strRef>
          </c:tx>
          <c:spPr>
            <a:solidFill>
              <a:srgbClr val="4FD1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J1'!$E$75:$G$75</c:f>
                <c:numCache>
                  <c:formatCode>General</c:formatCode>
                  <c:ptCount val="3"/>
                  <c:pt idx="0">
                    <c:v>479.16594202843754</c:v>
                  </c:pt>
                  <c:pt idx="1">
                    <c:v>135.64659966250537</c:v>
                  </c:pt>
                  <c:pt idx="2">
                    <c:v>40</c:v>
                  </c:pt>
                </c:numCache>
              </c:numRef>
            </c:plus>
            <c:minus>
              <c:numRef>
                <c:f>'Sheet J1'!$E$75:$G$75</c:f>
                <c:numCache>
                  <c:formatCode>General</c:formatCode>
                  <c:ptCount val="3"/>
                  <c:pt idx="0">
                    <c:v>479.16594202843754</c:v>
                  </c:pt>
                  <c:pt idx="1">
                    <c:v>135.64659966250537</c:v>
                  </c:pt>
                  <c:pt idx="2">
                    <c:v>40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J1'!$E$68:$G$68</c:f>
              <c:strCache>
                <c:ptCount val="3"/>
                <c:pt idx="0">
                  <c:v>CryJ1</c:v>
                </c:pt>
                <c:pt idx="1">
                  <c:v>Cry J2</c:v>
                </c:pt>
                <c:pt idx="2">
                  <c:v>Control</c:v>
                </c:pt>
              </c:strCache>
            </c:strRef>
          </c:cat>
          <c:val>
            <c:numRef>
              <c:f>'Sheet J1'!$E$70:$G$70</c:f>
              <c:numCache>
                <c:formatCode>General</c:formatCode>
                <c:ptCount val="3"/>
                <c:pt idx="0">
                  <c:v>860</c:v>
                </c:pt>
                <c:pt idx="1">
                  <c:v>380</c:v>
                </c:pt>
                <c:pt idx="2">
                  <c:v>14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8066808"/>
        <c:axId val="147951616"/>
      </c:barChart>
      <c:catAx>
        <c:axId val="148066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7951616"/>
        <c:crosses val="autoZero"/>
        <c:auto val="1"/>
        <c:lblAlgn val="ctr"/>
        <c:lblOffset val="100"/>
        <c:noMultiLvlLbl val="0"/>
      </c:catAx>
      <c:valAx>
        <c:axId val="147951616"/>
        <c:scaling>
          <c:orientation val="minMax"/>
          <c:max val="15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066808"/>
        <c:crosses val="autoZero"/>
        <c:crossBetween val="between"/>
        <c:majorUnit val="30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432250656167984"/>
          <c:y val="0.19303837020372452"/>
          <c:w val="0.36041338582677163"/>
          <c:h val="0.196932883389576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C797A4-5BA6-4707-820D-A4C26B7FBE0C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2F75A5-312B-42AA-ADB0-AC459E748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24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738" y="0"/>
            <a:ext cx="4029075" cy="3508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AD8FE-2CC7-4E98-88D4-B72459E1D417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60788" y="876300"/>
            <a:ext cx="1774825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275" y="3373438"/>
            <a:ext cx="7435850" cy="27606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738" y="6659563"/>
            <a:ext cx="4029075" cy="3508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32A20C-DCD4-4A57-88AC-AFFBE9E0CB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019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420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65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550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730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253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4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90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34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689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0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69859-6502-4D90-8591-68E827EDF5FD}" type="datetimeFigureOut">
              <a:rPr lang="en-US" smtClean="0"/>
              <a:t>3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E05B7-5DA7-47E2-98ED-1297B585E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83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9801275"/>
              </p:ext>
            </p:extLst>
          </p:nvPr>
        </p:nvGraphicFramePr>
        <p:xfrm>
          <a:off x="4771277" y="1320921"/>
          <a:ext cx="1828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503733"/>
              </p:ext>
            </p:extLst>
          </p:nvPr>
        </p:nvGraphicFramePr>
        <p:xfrm>
          <a:off x="2812460" y="1320921"/>
          <a:ext cx="1828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8356194"/>
              </p:ext>
            </p:extLst>
          </p:nvPr>
        </p:nvGraphicFramePr>
        <p:xfrm>
          <a:off x="853643" y="1320921"/>
          <a:ext cx="1828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05259" y="1255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A</a:t>
            </a:r>
            <a:endParaRPr lang="en-US" dirty="0">
              <a:solidFill>
                <a:prstClr val="black"/>
              </a:solidFill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60460" y="280320"/>
            <a:ext cx="5307303" cy="610032"/>
            <a:chOff x="660460" y="889920"/>
            <a:chExt cx="5307303" cy="610032"/>
          </a:xfrm>
        </p:grpSpPr>
        <p:cxnSp>
          <p:nvCxnSpPr>
            <p:cNvPr id="23" name="Straight Arrow Connector 22"/>
            <p:cNvCxnSpPr/>
            <p:nvPr/>
          </p:nvCxnSpPr>
          <p:spPr>
            <a:xfrm>
              <a:off x="776486" y="1020725"/>
              <a:ext cx="4715435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5521807" y="889920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prstClr val="black"/>
                  </a:solidFill>
                </a:rPr>
                <a:t>Days</a:t>
              </a:r>
              <a:endParaRPr lang="en-US" sz="1050" dirty="0">
                <a:solidFill>
                  <a:prstClr val="black"/>
                </a:solidFill>
              </a:endParaRPr>
            </a:p>
          </p:txBody>
        </p:sp>
        <p:sp>
          <p:nvSpPr>
            <p:cNvPr id="50" name="Down Arrow 49"/>
            <p:cNvSpPr>
              <a:spLocks/>
            </p:cNvSpPr>
            <p:nvPr/>
          </p:nvSpPr>
          <p:spPr>
            <a:xfrm>
              <a:off x="758787" y="901872"/>
              <a:ext cx="45720" cy="9144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60460" y="1014811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0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48" name="Down Arrow 47"/>
            <p:cNvSpPr/>
            <p:nvPr/>
          </p:nvSpPr>
          <p:spPr>
            <a:xfrm>
              <a:off x="5107413" y="901872"/>
              <a:ext cx="45720" cy="91440"/>
            </a:xfrm>
            <a:prstGeom prst="downArrow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009086" y="101481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16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36" name="Flowchart: Merge 35"/>
            <p:cNvSpPr/>
            <p:nvPr/>
          </p:nvSpPr>
          <p:spPr>
            <a:xfrm>
              <a:off x="1814174" y="902671"/>
              <a:ext cx="91440" cy="91440"/>
            </a:xfrm>
            <a:prstGeom prst="flowChartMerg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738707" y="1014811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1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21" name="Down Arrow 20"/>
            <p:cNvSpPr>
              <a:spLocks/>
            </p:cNvSpPr>
            <p:nvPr/>
          </p:nvSpPr>
          <p:spPr>
            <a:xfrm>
              <a:off x="758787" y="1338816"/>
              <a:ext cx="45720" cy="9144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prstClr val="white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91446" y="1269120"/>
              <a:ext cx="8499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T cell transfer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19" name="Down Arrow 18"/>
            <p:cNvSpPr/>
            <p:nvPr/>
          </p:nvSpPr>
          <p:spPr>
            <a:xfrm>
              <a:off x="2108629" y="1338816"/>
              <a:ext cx="45720" cy="91440"/>
            </a:xfrm>
            <a:prstGeom prst="downArrow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prstClr val="white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41288" y="1269120"/>
              <a:ext cx="450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Bleed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17" name="Flowchart: Merge 16"/>
            <p:cNvSpPr/>
            <p:nvPr/>
          </p:nvSpPr>
          <p:spPr>
            <a:xfrm>
              <a:off x="2812460" y="1338816"/>
              <a:ext cx="91440" cy="91440"/>
            </a:xfrm>
            <a:prstGeom prst="flowChartMerge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prstClr val="white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945119" y="1269120"/>
              <a:ext cx="12570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prstClr val="black"/>
                  </a:solidFill>
                </a:rPr>
                <a:t>CryJ1/CryJ2/Flea/Alum</a:t>
              </a:r>
              <a:endParaRPr lang="en-US" sz="900" dirty="0">
                <a:solidFill>
                  <a:prstClr val="black"/>
                </a:solidFill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305259" y="132092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B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227932" y="2767233"/>
            <a:ext cx="1622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</a:rPr>
              <a:t>IgG Antibody Titers </a:t>
            </a:r>
            <a:endParaRPr lang="en-US" sz="14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2112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48</TotalTime>
  <Words>17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</dc:creator>
  <cp:lastModifiedBy>Yan Su</cp:lastModifiedBy>
  <cp:revision>484</cp:revision>
  <cp:lastPrinted>2016-03-21T18:45:19Z</cp:lastPrinted>
  <dcterms:created xsi:type="dcterms:W3CDTF">2014-04-15T17:15:57Z</dcterms:created>
  <dcterms:modified xsi:type="dcterms:W3CDTF">2016-03-28T13:07:37Z</dcterms:modified>
</cp:coreProperties>
</file>